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3" orient="horz" pos="5738" userDrawn="1">
          <p15:clr>
            <a:srgbClr val="A4A3A4"/>
          </p15:clr>
        </p15:guide>
        <p15:guide id="14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hiruidie@163.com" initials="s" lastIdx="1" clrIdx="0">
    <p:extLst>
      <p:ext uri="{19B8F6BF-5375-455C-9EA6-DF929625EA0E}">
        <p15:presenceInfo xmlns:p15="http://schemas.microsoft.com/office/powerpoint/2012/main" userId="22cc39e04f12751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59" d="100"/>
          <a:sy n="59" d="100"/>
        </p:scale>
        <p:origin x="2568" y="82"/>
      </p:cViewPr>
      <p:guideLst>
        <p:guide orient="horz" pos="573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72F43-A8FD-41C9-B6EC-4BA7ACA27CD3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EE7EA3-EF3D-4903-B384-2FD21CD82E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99159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色谱图总图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EE7EA3-EF3D-4903-B384-2FD21CD82EDB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59391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2903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9074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4390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6123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0702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3384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043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2490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4397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7951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9665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FBFF2-BF61-4C53-B4A1-1E6EDECC0617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4708E-6090-4156-BB2C-7795E4726D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5637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图片 34">
            <a:extLst>
              <a:ext uri="{FF2B5EF4-FFF2-40B4-BE49-F238E27FC236}">
                <a16:creationId xmlns:a16="http://schemas.microsoft.com/office/drawing/2014/main" id="{0B0D5267-0BDD-3F3F-DDBB-8C9CAE89B6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940" y="3392492"/>
            <a:ext cx="1902461" cy="1690437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9990AB02-7F3E-FC45-D1FE-72278382CC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63599" y="1423311"/>
            <a:ext cx="1923109" cy="970580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724F3732-EA10-E133-E361-4AF424E15A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03035" y="1772417"/>
            <a:ext cx="1440160" cy="545546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BF78B08A-7062-8CD6-593B-CEA40448906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940" y="1619250"/>
            <a:ext cx="2111475" cy="710878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AB1000B3-C2E8-3F8E-5C08-3467C8FB1E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05312" y="3392492"/>
            <a:ext cx="1872471" cy="1590323"/>
          </a:xfrm>
          <a:prstGeom prst="rect">
            <a:avLst/>
          </a:prstGeom>
        </p:spPr>
      </p:pic>
      <p:sp>
        <p:nvSpPr>
          <p:cNvPr id="55" name="文本框 54">
            <a:extLst>
              <a:ext uri="{FF2B5EF4-FFF2-40B4-BE49-F238E27FC236}">
                <a16:creationId xmlns:a16="http://schemas.microsoft.com/office/drawing/2014/main" id="{70E01293-57F4-3CC7-C59B-3397B0E5BAE1}"/>
              </a:ext>
            </a:extLst>
          </p:cNvPr>
          <p:cNvSpPr txBox="1"/>
          <p:nvPr/>
        </p:nvSpPr>
        <p:spPr>
          <a:xfrm>
            <a:off x="8816" y="123872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D69DF120-556E-EB95-3177-4EF5FFBDE41F}"/>
              </a:ext>
            </a:extLst>
          </p:cNvPr>
          <p:cNvSpPr txBox="1"/>
          <p:nvPr/>
        </p:nvSpPr>
        <p:spPr>
          <a:xfrm>
            <a:off x="4365104" y="1238726"/>
            <a:ext cx="4261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0878D28E-D741-3B44-F895-B3FB7055461C}"/>
              </a:ext>
            </a:extLst>
          </p:cNvPr>
          <p:cNvSpPr txBox="1"/>
          <p:nvPr/>
        </p:nvSpPr>
        <p:spPr>
          <a:xfrm flipH="1">
            <a:off x="2226398" y="1238726"/>
            <a:ext cx="5319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73F858A8-F6B8-FA6B-6B7C-C2D1E08B7599}"/>
              </a:ext>
            </a:extLst>
          </p:cNvPr>
          <p:cNvSpPr txBox="1"/>
          <p:nvPr/>
        </p:nvSpPr>
        <p:spPr>
          <a:xfrm>
            <a:off x="8816" y="323423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67DB5FDD-57E5-AB8C-3AF2-BB4CA95087A2}"/>
              </a:ext>
            </a:extLst>
          </p:cNvPr>
          <p:cNvSpPr txBox="1"/>
          <p:nvPr/>
        </p:nvSpPr>
        <p:spPr>
          <a:xfrm>
            <a:off x="3730288" y="3234236"/>
            <a:ext cx="3048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F92B7BF-5754-B696-89A6-87837EE0E241}"/>
              </a:ext>
            </a:extLst>
          </p:cNvPr>
          <p:cNvSpPr txBox="1"/>
          <p:nvPr/>
        </p:nvSpPr>
        <p:spPr>
          <a:xfrm>
            <a:off x="692696" y="5508104"/>
            <a:ext cx="54726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sz="1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: (A-E) The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ructures of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ryptochlorogenic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cid, caffeic acid, chlorogenic acid,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sperulosidic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cid, and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speruloside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re shown, respectively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2974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6</TotalTime>
  <Words>39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Palatino Linotype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DL</dc:creator>
  <cp:lastModifiedBy>MDPI</cp:lastModifiedBy>
  <cp:revision>89</cp:revision>
  <dcterms:created xsi:type="dcterms:W3CDTF">2021-09-15T07:07:32Z</dcterms:created>
  <dcterms:modified xsi:type="dcterms:W3CDTF">2025-03-17T05:12:24Z</dcterms:modified>
</cp:coreProperties>
</file>